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60"/>
    <p:restoredTop sz="94631"/>
  </p:normalViewPr>
  <p:slideViewPr>
    <p:cSldViewPr snapToGrid="0" snapToObjects="1">
      <p:cViewPr varScale="1">
        <p:scale>
          <a:sx n="97" d="100"/>
          <a:sy n="97" d="100"/>
        </p:scale>
        <p:origin x="16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9B86C6-5DE2-E140-8AE4-5231438C5D0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C338AF-EEFE-B94E-8314-75D55FC3922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317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294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3196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980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122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912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9092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664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033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212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030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565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2A031-6540-4541-8491-B01DA70BC8E9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D0E40-E2BE-1A46-B63E-18F5D98EE6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3424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F0C471E-296A-9149-9DFF-2D9BD46147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191" y="355600"/>
            <a:ext cx="9171609" cy="572043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DB935A9-BE36-7046-9AF7-666B3C740052}"/>
              </a:ext>
            </a:extLst>
          </p:cNvPr>
          <p:cNvSpPr txBox="1"/>
          <p:nvPr/>
        </p:nvSpPr>
        <p:spPr>
          <a:xfrm>
            <a:off x="5153891" y="355600"/>
            <a:ext cx="1455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uster of sample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EA8D2F4-E28E-644F-AA50-A4AC3BEBA3C7}"/>
              </a:ext>
            </a:extLst>
          </p:cNvPr>
          <p:cNvSpPr txBox="1"/>
          <p:nvPr/>
        </p:nvSpPr>
        <p:spPr>
          <a:xfrm rot="16200000">
            <a:off x="-13855" y="3290500"/>
            <a:ext cx="19752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uster of protein domain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5F32A057-7AE3-954E-A459-86AAB766D500}"/>
              </a:ext>
            </a:extLst>
          </p:cNvPr>
          <p:cNvSpPr/>
          <p:nvPr/>
        </p:nvSpPr>
        <p:spPr>
          <a:xfrm>
            <a:off x="718886" y="6076037"/>
            <a:ext cx="85427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 S7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Heatmap analysis of the protein domains using the full set of environmental metagenomic data. </a:t>
            </a:r>
            <a:endParaRPr lang="ja-JP" altLang="ja-JP" sz="20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7046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25</Words>
  <Application>Microsoft Macintosh PowerPoint</Application>
  <PresentationFormat>A4 210 x 297 mm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明朝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五十嵐洋治</cp:lastModifiedBy>
  <cp:revision>12</cp:revision>
  <cp:lastPrinted>2019-01-31T10:38:15Z</cp:lastPrinted>
  <dcterms:created xsi:type="dcterms:W3CDTF">2018-12-21T01:45:07Z</dcterms:created>
  <dcterms:modified xsi:type="dcterms:W3CDTF">2019-02-20T05:20:54Z</dcterms:modified>
</cp:coreProperties>
</file>